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media/image8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E176D8-2D35-420E-ABB3-36B9CFFA5D9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7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8A65D15-6069-4B63-AD8A-574BA4779061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4753F1-F9AF-49E8-AC47-185C4B712D5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88CDB9-2487-4709-9F66-201D5C5B9882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FC87CA7-13AB-4AD4-A6D5-BDB300F57C5C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59515E-6E4F-47CB-BAF6-C1771FE706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BC7703-F043-4C17-9223-F98DB98E31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C7E794-C9B7-4885-B52E-9C0A14B14F0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38275-F1D4-4604-A68C-9366B7B0DD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ACF036-332A-4283-9E00-AF234CB81C6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8BFF68-84A9-4A95-B684-9DD6DD2452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B1975C-E905-4DB3-8D87-DDC2AB1711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F76017-3B6B-4C8B-A6CE-F6F19E476A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190EE9-6ECC-43DF-8E4E-3935A3D774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FB07D-B8B8-4F03-9C28-84ED18362B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14494-181A-4496-B3CC-2A815E62B4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EC30E-9B54-47EC-AA92-B7CC0382F0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4365472-A9B9-42F1-8FB3-72ED1379D88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4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C:\Users\Qi Mi\Documents\My project\Shock\Figure\network\sham01.png"/>
          <p:cNvPicPr/>
          <p:nvPr/>
        </p:nvPicPr>
        <p:blipFill>
          <a:blip r:embed="rId1"/>
          <a:stretch/>
        </p:blipFill>
        <p:spPr>
          <a:xfrm>
            <a:off x="380880" y="762120"/>
            <a:ext cx="3876840" cy="51940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C:\Users\Qi Mi\Documents\My project\Shock\Figure\network\shock01.png"/>
          <p:cNvPicPr/>
          <p:nvPr/>
        </p:nvPicPr>
        <p:blipFill>
          <a:blip r:embed="rId2"/>
          <a:stretch/>
        </p:blipFill>
        <p:spPr>
          <a:xfrm>
            <a:off x="4800600" y="609480"/>
            <a:ext cx="3962520" cy="5486400"/>
          </a:xfrm>
          <a:prstGeom prst="rect">
            <a:avLst/>
          </a:prstGeom>
          <a:ln w="0">
            <a:noFill/>
          </a:ln>
        </p:spPr>
      </p:pic>
      <p:sp>
        <p:nvSpPr>
          <p:cNvPr id="50" name="Rectangle 5"/>
          <p:cNvSpPr/>
          <p:nvPr/>
        </p:nvSpPr>
        <p:spPr>
          <a:xfrm>
            <a:off x="3809880" y="773280"/>
            <a:ext cx="16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DyNA: 0 - 1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6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7"/>
          <p:cNvSpPr/>
          <p:nvPr/>
        </p:nvSpPr>
        <p:spPr>
          <a:xfrm>
            <a:off x="383760" y="762120"/>
            <a:ext cx="511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8"/>
          <p:cNvSpPr/>
          <p:nvPr/>
        </p:nvSpPr>
        <p:spPr>
          <a:xfrm>
            <a:off x="1967760" y="5105520"/>
            <a:ext cx="56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9"/>
          <p:cNvSpPr/>
          <p:nvPr/>
        </p:nvSpPr>
        <p:spPr>
          <a:xfrm>
            <a:off x="6178680" y="5105520"/>
            <a:ext cx="1340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T + H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Picture 1" descr="C:\Users\Qi Mi\Documents\My project\Shock\Figure\network\sham12.png"/>
          <p:cNvPicPr/>
          <p:nvPr/>
        </p:nvPicPr>
        <p:blipFill>
          <a:blip r:embed="rId1"/>
          <a:stretch/>
        </p:blipFill>
        <p:spPr>
          <a:xfrm>
            <a:off x="0" y="304920"/>
            <a:ext cx="4362480" cy="57909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2" descr="C:\Users\Qi Mi\Documents\My project\Shock\Figure\network\shock12.png"/>
          <p:cNvPicPr/>
          <p:nvPr/>
        </p:nvPicPr>
        <p:blipFill>
          <a:blip r:embed="rId2"/>
          <a:stretch/>
        </p:blipFill>
        <p:spPr>
          <a:xfrm>
            <a:off x="4572000" y="304920"/>
            <a:ext cx="4110120" cy="5803920"/>
          </a:xfrm>
          <a:prstGeom prst="rect">
            <a:avLst/>
          </a:prstGeom>
          <a:ln w="0">
            <a:noFill/>
          </a:ln>
        </p:spPr>
      </p:pic>
      <p:sp>
        <p:nvSpPr>
          <p:cNvPr id="57" name="TextBox 3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4"/>
          <p:cNvSpPr/>
          <p:nvPr/>
        </p:nvSpPr>
        <p:spPr>
          <a:xfrm>
            <a:off x="3809880" y="773280"/>
            <a:ext cx="1828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DyNA: 1 - 2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5"/>
          <p:cNvSpPr/>
          <p:nvPr/>
        </p:nvSpPr>
        <p:spPr>
          <a:xfrm>
            <a:off x="1967760" y="5105520"/>
            <a:ext cx="56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6"/>
          <p:cNvSpPr/>
          <p:nvPr/>
        </p:nvSpPr>
        <p:spPr>
          <a:xfrm>
            <a:off x="6178680" y="5105520"/>
            <a:ext cx="1340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T + H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7"/>
          <p:cNvSpPr/>
          <p:nvPr/>
        </p:nvSpPr>
        <p:spPr>
          <a:xfrm>
            <a:off x="383760" y="762120"/>
            <a:ext cx="511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1" descr="C:\Users\Qi Mi\Documents\My project\Shock\Figure\network\sham23.png"/>
          <p:cNvPicPr/>
          <p:nvPr/>
        </p:nvPicPr>
        <p:blipFill>
          <a:blip r:embed="rId1"/>
          <a:stretch/>
        </p:blipFill>
        <p:spPr>
          <a:xfrm>
            <a:off x="152280" y="0"/>
            <a:ext cx="4421160" cy="634824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2" descr="C:\Users\Qi Mi\Documents\My project\Shock\Figure\network\shock23.png"/>
          <p:cNvPicPr/>
          <p:nvPr/>
        </p:nvPicPr>
        <p:blipFill>
          <a:blip r:embed="rId2"/>
          <a:stretch/>
        </p:blipFill>
        <p:spPr>
          <a:xfrm>
            <a:off x="4595760" y="0"/>
            <a:ext cx="4548240" cy="6423120"/>
          </a:xfrm>
          <a:prstGeom prst="rect">
            <a:avLst/>
          </a:prstGeom>
          <a:ln w="0">
            <a:noFill/>
          </a:ln>
        </p:spPr>
      </p:pic>
      <p:sp>
        <p:nvSpPr>
          <p:cNvPr id="64" name="TextBox 3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"/>
          <p:cNvSpPr/>
          <p:nvPr/>
        </p:nvSpPr>
        <p:spPr>
          <a:xfrm>
            <a:off x="3809880" y="773280"/>
            <a:ext cx="16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DyNA: 2 - 3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5"/>
          <p:cNvSpPr/>
          <p:nvPr/>
        </p:nvSpPr>
        <p:spPr>
          <a:xfrm>
            <a:off x="1967760" y="5191200"/>
            <a:ext cx="56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6"/>
          <p:cNvSpPr/>
          <p:nvPr/>
        </p:nvSpPr>
        <p:spPr>
          <a:xfrm>
            <a:off x="6178680" y="5191200"/>
            <a:ext cx="1340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T + H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7"/>
          <p:cNvSpPr/>
          <p:nvPr/>
        </p:nvSpPr>
        <p:spPr>
          <a:xfrm>
            <a:off x="383760" y="762120"/>
            <a:ext cx="511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1" descr="C:\Users\Qi Mi\Documents\My project\Shock\Figure\network\sham34.png"/>
          <p:cNvPicPr/>
          <p:nvPr/>
        </p:nvPicPr>
        <p:blipFill>
          <a:blip r:embed="rId1"/>
          <a:stretch/>
        </p:blipFill>
        <p:spPr>
          <a:xfrm>
            <a:off x="200160" y="228600"/>
            <a:ext cx="4219560" cy="59594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2" descr="C:\Users\Qi Mi\Documents\My project\Shock\Figure\network\shock34.png"/>
          <p:cNvPicPr/>
          <p:nvPr/>
        </p:nvPicPr>
        <p:blipFill>
          <a:blip r:embed="rId2"/>
          <a:stretch/>
        </p:blipFill>
        <p:spPr>
          <a:xfrm>
            <a:off x="4648320" y="76320"/>
            <a:ext cx="4243320" cy="6195960"/>
          </a:xfrm>
          <a:prstGeom prst="rect">
            <a:avLst/>
          </a:prstGeom>
          <a:ln w="0">
            <a:noFill/>
          </a:ln>
        </p:spPr>
      </p:pic>
      <p:sp>
        <p:nvSpPr>
          <p:cNvPr id="71" name="TextBox 3"/>
          <p:cNvSpPr/>
          <p:nvPr/>
        </p:nvSpPr>
        <p:spPr>
          <a:xfrm>
            <a:off x="3240" y="0"/>
            <a:ext cx="1630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Mi </a:t>
            </a:r>
            <a:r>
              <a:rPr b="0" i="1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et al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宋体"/>
              </a:rPr>
              <a:t>, Figure S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4"/>
          <p:cNvSpPr/>
          <p:nvPr/>
        </p:nvSpPr>
        <p:spPr>
          <a:xfrm>
            <a:off x="3809880" y="773280"/>
            <a:ext cx="167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  <a:ea typeface="宋体"/>
              </a:rPr>
              <a:t>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宋体"/>
              </a:rPr>
              <a:t>DyNA: 3 - 4 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5"/>
          <p:cNvSpPr/>
          <p:nvPr/>
        </p:nvSpPr>
        <p:spPr>
          <a:xfrm>
            <a:off x="1832760" y="5105520"/>
            <a:ext cx="569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6"/>
          <p:cNvSpPr/>
          <p:nvPr/>
        </p:nvSpPr>
        <p:spPr>
          <a:xfrm>
            <a:off x="6178680" y="5105520"/>
            <a:ext cx="134064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  <a:ea typeface="Arial"/>
              </a:rPr>
              <a:t>ST + HS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7"/>
          <p:cNvSpPr/>
          <p:nvPr/>
        </p:nvSpPr>
        <p:spPr>
          <a:xfrm>
            <a:off x="383760" y="762120"/>
            <a:ext cx="511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27T17:19:41Z</dcterms:created>
  <dc:creator> Yoram Vodovotz</dc:creator>
  <dc:description/>
  <dc:language>en-US</dc:language>
  <cp:lastModifiedBy>qim3</cp:lastModifiedBy>
  <dcterms:modified xsi:type="dcterms:W3CDTF">2010-11-20T01:39:05Z</dcterms:modified>
  <cp:revision>6</cp:revision>
  <dc:subject/>
  <dc:title>Slide 1</dc:title>
</cp:coreProperties>
</file>